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2647" autoAdjust="0"/>
  </p:normalViewPr>
  <p:slideViewPr>
    <p:cSldViewPr snapToGrid="0" showGuides="1">
      <p:cViewPr varScale="1">
        <p:scale>
          <a:sx n="97" d="100"/>
          <a:sy n="97" d="100"/>
        </p:scale>
        <p:origin x="124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HRI\HALST\Physical%20activity\Work-related%20physical%20activit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HRI\HALST\Physical%20activity\Work-related%20physical%20activit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TW" sz="90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view3D>
      <c:rotX val="15"/>
      <c:rotY val="2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standard"/>
        <c:varyColors val="0"/>
        <c:ser>
          <c:idx val="14"/>
          <c:order val="0"/>
          <c:tx>
            <c:strRef>
              <c:f>LE!$U$1:$U$2</c:f>
              <c:strCache>
                <c:ptCount val="2"/>
                <c:pt idx="0">
                  <c:v>Disability-free life expectancy</c:v>
                </c:pt>
                <c:pt idx="1">
                  <c:v>STD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!$U$3:$U$77</c:f>
            </c:numRef>
          </c:val>
          <c:extLst>
            <c:ext xmlns:c16="http://schemas.microsoft.com/office/drawing/2014/chart" uri="{C3380CC4-5D6E-409C-BE32-E72D297353CC}">
              <c16:uniqueId val="{00000000-C239-4871-ABF2-735E584AC078}"/>
            </c:ext>
          </c:extLst>
        </c:ser>
        <c:ser>
          <c:idx val="18"/>
          <c:order val="1"/>
          <c:tx>
            <c:strRef>
              <c:f>LE!$Y$1:$Y$2</c:f>
              <c:strCache>
                <c:ptCount val="2"/>
                <c:pt idx="0">
                  <c:v>Disabled life expectancy</c:v>
                </c:pt>
                <c:pt idx="1">
                  <c:v>ST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!$Y$3:$Y$77</c:f>
            </c:numRef>
          </c:val>
          <c:extLst>
            <c:ext xmlns:c16="http://schemas.microsoft.com/office/drawing/2014/chart" uri="{C3380CC4-5D6E-409C-BE32-E72D297353CC}">
              <c16:uniqueId val="{00000001-C239-4871-ABF2-735E584AC078}"/>
            </c:ext>
          </c:extLst>
        </c:ser>
        <c:ser>
          <c:idx val="0"/>
          <c:order val="2"/>
          <c:tx>
            <c:strRef>
              <c:f>LE_WPA!$B$13</c:f>
              <c:strCache>
                <c:ptCount val="1"/>
                <c:pt idx="0">
                  <c:v>&lt;30K NT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-5.5555555555555558E-3"/>
                  <c:y val="7.407407407407402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239-4871-ABF2-735E584AC078}"/>
                </c:ext>
              </c:extLst>
            </c:dLbl>
            <c:dLbl>
              <c:idx val="1"/>
              <c:layout>
                <c:manualLayout>
                  <c:x val="0"/>
                  <c:y val="6.48148148148148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239-4871-ABF2-735E584AC078}"/>
                </c:ext>
              </c:extLst>
            </c:dLbl>
            <c:dLbl>
              <c:idx val="2"/>
              <c:layout>
                <c:manualLayout>
                  <c:x val="0"/>
                  <c:y val="7.407407407407402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C239-4871-ABF2-735E584AC0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13:$L$15</c:f>
              <c:numCache>
                <c:formatCode>0.00</c:formatCode>
                <c:ptCount val="3"/>
                <c:pt idx="0">
                  <c:v>2.383775</c:v>
                </c:pt>
                <c:pt idx="1">
                  <c:v>2.274985</c:v>
                </c:pt>
                <c:pt idx="2">
                  <c:v>2.49528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239-4871-ABF2-735E584AC078}"/>
            </c:ext>
          </c:extLst>
        </c:ser>
        <c:ser>
          <c:idx val="1"/>
          <c:order val="3"/>
          <c:tx>
            <c:strRef>
              <c:f>LE_WPA!$B$16</c:f>
              <c:strCache>
                <c:ptCount val="1"/>
                <c:pt idx="0">
                  <c:v>30K - &lt;70K NT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1.3888888888888888E-2"/>
                  <c:y val="7.40740740740740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C239-4871-ABF2-735E584AC078}"/>
                </c:ext>
              </c:extLst>
            </c:dLbl>
            <c:dLbl>
              <c:idx val="1"/>
              <c:layout>
                <c:manualLayout>
                  <c:x val="2.7777777777777776E-2"/>
                  <c:y val="6.94444444444443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C239-4871-ABF2-735E584AC078}"/>
                </c:ext>
              </c:extLst>
            </c:dLbl>
            <c:dLbl>
              <c:idx val="2"/>
              <c:layout>
                <c:manualLayout>
                  <c:x val="3.3333333333333333E-2"/>
                  <c:y val="6.94444444444444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C239-4871-ABF2-735E584AC0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16:$L$18</c:f>
              <c:numCache>
                <c:formatCode>0.00</c:formatCode>
                <c:ptCount val="3"/>
                <c:pt idx="0">
                  <c:v>1.9113450000000001</c:v>
                </c:pt>
                <c:pt idx="1">
                  <c:v>1.7708950000000001</c:v>
                </c:pt>
                <c:pt idx="2">
                  <c:v>1.9729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239-4871-ABF2-735E584AC078}"/>
            </c:ext>
          </c:extLst>
        </c:ser>
        <c:ser>
          <c:idx val="2"/>
          <c:order val="4"/>
          <c:tx>
            <c:strRef>
              <c:f>LE_WPA!$B$19</c:f>
              <c:strCache>
                <c:ptCount val="1"/>
                <c:pt idx="0">
                  <c:v>≥70K NT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2.7777777777777779E-3"/>
                  <c:y val="6.48148148148148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C239-4871-ABF2-735E584AC078}"/>
                </c:ext>
              </c:extLst>
            </c:dLbl>
            <c:dLbl>
              <c:idx val="1"/>
              <c:layout>
                <c:manualLayout>
                  <c:x val="-1.3888888888888888E-2"/>
                  <c:y val="6.94444444444444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C239-4871-ABF2-735E584AC078}"/>
                </c:ext>
              </c:extLst>
            </c:dLbl>
            <c:dLbl>
              <c:idx val="2"/>
              <c:layout>
                <c:manualLayout>
                  <c:x val="1.1111111111111112E-2"/>
                  <c:y val="6.944444444444444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C239-4871-ABF2-735E584AC0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19:$L$21</c:f>
              <c:numCache>
                <c:formatCode>0.00</c:formatCode>
                <c:ptCount val="3"/>
                <c:pt idx="0">
                  <c:v>2.18499</c:v>
                </c:pt>
                <c:pt idx="1">
                  <c:v>2.0094850000000002</c:v>
                </c:pt>
                <c:pt idx="2">
                  <c:v>2.20621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239-4871-ABF2-735E584AC078}"/>
            </c:ext>
          </c:extLst>
        </c:ser>
        <c:ser>
          <c:idx val="3"/>
          <c:order val="5"/>
          <c:tx>
            <c:strRef>
              <c:f>LE_WPA!$B$22</c:f>
              <c:strCache>
                <c:ptCount val="1"/>
                <c:pt idx="0">
                  <c:v>Unknown or refuse to answer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13:$C$15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22:$L$24</c:f>
              <c:numCache>
                <c:formatCode>0.00</c:formatCode>
                <c:ptCount val="3"/>
                <c:pt idx="0">
                  <c:v>2.2612450000000002</c:v>
                </c:pt>
                <c:pt idx="1">
                  <c:v>2.1502500000000002</c:v>
                </c:pt>
                <c:pt idx="2">
                  <c:v>2.34992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239-4871-ABF2-735E584AC0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007457088"/>
        <c:axId val="1007448352"/>
        <c:axId val="1557066208"/>
      </c:bar3DChart>
      <c:catAx>
        <c:axId val="1007457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1007448352"/>
        <c:crosses val="autoZero"/>
        <c:auto val="1"/>
        <c:lblAlgn val="ctr"/>
        <c:lblOffset val="100"/>
        <c:noMultiLvlLbl val="0"/>
      </c:catAx>
      <c:valAx>
        <c:axId val="1007448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TW" sz="800">
                    <a:latin typeface="Arial" panose="020B0604020202020204" pitchFamily="34" charset="0"/>
                    <a:cs typeface="Arial" panose="020B0604020202020204" pitchFamily="34" charset="0"/>
                  </a:rPr>
                  <a:t>Disabled year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#,##0.0_);[Red]\(#,##0.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1007457088"/>
        <c:crosses val="autoZero"/>
        <c:crossBetween val="between"/>
      </c:valAx>
      <c:serAx>
        <c:axId val="15570662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007448352"/>
        <c:crosses val="autoZero"/>
      </c:ser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TW" sz="90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view3D>
      <c:rotX val="15"/>
      <c:rotY val="2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standard"/>
        <c:varyColors val="0"/>
        <c:ser>
          <c:idx val="14"/>
          <c:order val="0"/>
          <c:tx>
            <c:strRef>
              <c:f>LE!$U$1:$U$2</c:f>
              <c:strCache>
                <c:ptCount val="2"/>
                <c:pt idx="0">
                  <c:v>Disability-free life expectancy</c:v>
                </c:pt>
                <c:pt idx="1">
                  <c:v>STD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!$U$3:$U$77</c:f>
            </c:numRef>
          </c:val>
          <c:extLst>
            <c:ext xmlns:c16="http://schemas.microsoft.com/office/drawing/2014/chart" uri="{C3380CC4-5D6E-409C-BE32-E72D297353CC}">
              <c16:uniqueId val="{00000000-8475-429A-BEFE-B479109621E2}"/>
            </c:ext>
          </c:extLst>
        </c:ser>
        <c:ser>
          <c:idx val="18"/>
          <c:order val="1"/>
          <c:tx>
            <c:strRef>
              <c:f>LE!$Y$1:$Y$2</c:f>
              <c:strCache>
                <c:ptCount val="2"/>
                <c:pt idx="0">
                  <c:v>Disabled life expectancy</c:v>
                </c:pt>
                <c:pt idx="1">
                  <c:v>ST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!$Y$3:$Y$77</c:f>
            </c:numRef>
          </c:val>
          <c:extLst>
            <c:ext xmlns:c16="http://schemas.microsoft.com/office/drawing/2014/chart" uri="{C3380CC4-5D6E-409C-BE32-E72D297353CC}">
              <c16:uniqueId val="{00000001-8475-429A-BEFE-B479109621E2}"/>
            </c:ext>
          </c:extLst>
        </c:ser>
        <c:ser>
          <c:idx val="0"/>
          <c:order val="2"/>
          <c:tx>
            <c:strRef>
              <c:f>LE_WPA!$B$91</c:f>
              <c:strCache>
                <c:ptCount val="1"/>
                <c:pt idx="0">
                  <c:v>&lt;30K NT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-2.8096738003906189E-17"/>
                  <c:y val="6.944444444444444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8475-429A-BEFE-B479109621E2}"/>
                </c:ext>
              </c:extLst>
            </c:dLbl>
            <c:dLbl>
              <c:idx val="1"/>
              <c:layout>
                <c:manualLayout>
                  <c:x val="0"/>
                  <c:y val="6.944444444444444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475-429A-BEFE-B479109621E2}"/>
                </c:ext>
              </c:extLst>
            </c:dLbl>
            <c:dLbl>
              <c:idx val="2"/>
              <c:layout>
                <c:manualLayout>
                  <c:x val="-5.6193476007812378E-17"/>
                  <c:y val="8.333333333333332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8475-429A-BEFE-B479109621E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91:$L$93</c:f>
              <c:numCache>
                <c:formatCode>0.00</c:formatCode>
                <c:ptCount val="3"/>
                <c:pt idx="0">
                  <c:v>5.6728649999999998</c:v>
                </c:pt>
                <c:pt idx="1">
                  <c:v>3.0785550000000002</c:v>
                </c:pt>
                <c:pt idx="2">
                  <c:v>4.32010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475-429A-BEFE-B479109621E2}"/>
            </c:ext>
          </c:extLst>
        </c:ser>
        <c:ser>
          <c:idx val="1"/>
          <c:order val="3"/>
          <c:tx>
            <c:strRef>
              <c:f>LE_WPA!$B$94</c:f>
              <c:strCache>
                <c:ptCount val="1"/>
                <c:pt idx="0">
                  <c:v>30K - &lt;70K NT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1.2260536398467433E-2"/>
                  <c:y val="6.48148148148148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8475-429A-BEFE-B479109621E2}"/>
                </c:ext>
              </c:extLst>
            </c:dLbl>
            <c:dLbl>
              <c:idx val="1"/>
              <c:layout>
                <c:manualLayout>
                  <c:x val="2.7586206896551668E-2"/>
                  <c:y val="7.40740740740740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475-429A-BEFE-B479109621E2}"/>
                </c:ext>
              </c:extLst>
            </c:dLbl>
            <c:dLbl>
              <c:idx val="2"/>
              <c:layout>
                <c:manualLayout>
                  <c:x val="3.6781609195402354E-2"/>
                  <c:y val="7.87037037037037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8475-429A-BEFE-B479109621E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94:$L$96</c:f>
              <c:numCache>
                <c:formatCode>0.00</c:formatCode>
                <c:ptCount val="3"/>
                <c:pt idx="0">
                  <c:v>4.4124499999999998</c:v>
                </c:pt>
                <c:pt idx="1">
                  <c:v>2.4103750000000002</c:v>
                </c:pt>
                <c:pt idx="2">
                  <c:v>3.36081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8475-429A-BEFE-B479109621E2}"/>
            </c:ext>
          </c:extLst>
        </c:ser>
        <c:ser>
          <c:idx val="2"/>
          <c:order val="4"/>
          <c:tx>
            <c:strRef>
              <c:f>LE_WPA!$B$97</c:f>
              <c:strCache>
                <c:ptCount val="1"/>
                <c:pt idx="0">
                  <c:v>≥70K NT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2.4521072796934811E-2"/>
                  <c:y val="6.94444444444444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8475-429A-BEFE-B479109621E2}"/>
                </c:ext>
              </c:extLst>
            </c:dLbl>
            <c:dLbl>
              <c:idx val="1"/>
              <c:layout>
                <c:manualLayout>
                  <c:x val="-1.8390804597701205E-2"/>
                  <c:y val="6.48148148148148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8475-429A-BEFE-B479109621E2}"/>
                </c:ext>
              </c:extLst>
            </c:dLbl>
            <c:dLbl>
              <c:idx val="2"/>
              <c:layout>
                <c:manualLayout>
                  <c:x val="9.1954022988505746E-3"/>
                  <c:y val="5.55555555555555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8475-429A-BEFE-B479109621E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97:$L$99</c:f>
              <c:numCache>
                <c:formatCode>0.00</c:formatCode>
                <c:ptCount val="3"/>
                <c:pt idx="0">
                  <c:v>4.4692449999999999</c:v>
                </c:pt>
                <c:pt idx="1">
                  <c:v>2.6669550000000002</c:v>
                </c:pt>
                <c:pt idx="2">
                  <c:v>3.62042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8475-429A-BEFE-B479109621E2}"/>
            </c:ext>
          </c:extLst>
        </c:ser>
        <c:ser>
          <c:idx val="3"/>
          <c:order val="5"/>
          <c:tx>
            <c:strRef>
              <c:f>LE_WPA!$B$100</c:f>
              <c:strCache>
                <c:ptCount val="1"/>
                <c:pt idx="0">
                  <c:v>Unknown or refuse to answer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LE_WPA!$C$91:$C$93</c:f>
              <c:strCache>
                <c:ptCount val="3"/>
                <c:pt idx="0">
                  <c:v>No</c:v>
                </c:pt>
                <c:pt idx="1">
                  <c:v>Low</c:v>
                </c:pt>
                <c:pt idx="2">
                  <c:v>High</c:v>
                </c:pt>
              </c:strCache>
            </c:strRef>
          </c:cat>
          <c:val>
            <c:numRef>
              <c:f>LE_WPA!$L$100:$L$102</c:f>
              <c:numCache>
                <c:formatCode>0.00</c:formatCode>
                <c:ptCount val="3"/>
                <c:pt idx="0">
                  <c:v>5.235455</c:v>
                </c:pt>
                <c:pt idx="1">
                  <c:v>2.8008199999999999</c:v>
                </c:pt>
                <c:pt idx="2">
                  <c:v>3.98566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475-429A-BEFE-B479109621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007457088"/>
        <c:axId val="1007448352"/>
        <c:axId val="1557066208"/>
      </c:bar3DChart>
      <c:catAx>
        <c:axId val="1007457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1007448352"/>
        <c:crosses val="autoZero"/>
        <c:auto val="1"/>
        <c:lblAlgn val="ctr"/>
        <c:lblOffset val="100"/>
        <c:noMultiLvlLbl val="0"/>
      </c:catAx>
      <c:valAx>
        <c:axId val="1007448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TW" sz="800">
                    <a:latin typeface="Arial" panose="020B0604020202020204" pitchFamily="34" charset="0"/>
                    <a:cs typeface="Arial" panose="020B0604020202020204" pitchFamily="34" charset="0"/>
                  </a:rPr>
                  <a:t>Disabled year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#,##0.0_);[Red]\(#,##0.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1007457088"/>
        <c:crosses val="autoZero"/>
        <c:crossBetween val="between"/>
      </c:valAx>
      <c:serAx>
        <c:axId val="15570662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007448352"/>
        <c:crosses val="autoZero"/>
      </c:ser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E56D5-ABAD-4742-914D-3F2C83546C04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0DE890-DD1A-41C4-A159-580B210817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48730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Supplementary Figure 1. Flow chart of the recruitment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DE890-DD1A-41C4-A159-580B210817B0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69580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Supplementary Figure 2. Sample included in the analyses.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DE890-DD1A-41C4-A159-580B210817B0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685559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Supplementary Figure 3. </a:t>
            </a:r>
            <a:r>
              <a:rPr lang="en-US" altLang="zh-TW" sz="1200" dirty="0">
                <a:effectLst/>
                <a:latin typeface="Arial" panose="020B0604020202020204" pitchFamily="34" charset="0"/>
                <a:ea typeface="新細明體" panose="02020500000000000000" pitchFamily="18" charset="-120"/>
              </a:rPr>
              <a:t>Disabled life expectancies at 65 years old by household income and work-related physical activity levels in men and women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DE890-DD1A-41C4-A159-580B210817B0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50398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B50457B-EBE4-9C3E-7542-60ABE26B6E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CEC9D641-7E8E-8524-9C24-41EF6C5E21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7B4043F-2508-8F30-9618-A5CA4901B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8A1BE1A-A8B0-3CCF-D2C4-889DD65C0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231E8A1-22AB-E406-6473-A22810669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4072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8430B34-D4D9-9462-040C-698D7BB5C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FF7ADB2D-F326-AAE5-E59F-25D28950BC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E0BEF7D-9B23-E376-75AC-E4742D15C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36B6C11-CD58-8B58-AA65-5BD63A46B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A6FE626-F72B-33F4-2A50-9CC93054C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35413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79AACE2E-C90C-2106-A8F9-98AD85C432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219FFD3-DB67-5307-ADE3-6E2431B8E2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1932D14-886A-6861-AE63-C4452D03B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49F6F7F-AAB7-A15B-402C-5D7B64E4E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596A8C8-D609-5E6E-D795-30F7641EA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3483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32DFDFA-1145-8428-00E3-C5F2E519C6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39B5ABD-F47D-2F31-5095-80FC8CA329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5FE52E6-A78D-5453-59E1-351194F6D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F4847B7-2B22-C204-E772-DA617CC83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D6D802E-F214-6ACA-08F9-EC4EF8C59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5909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A82C816-C1F8-A9FA-50ED-D7E0C60EA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B904C030-F3B4-E4A5-68CB-DE0CEC3383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CF1BC09-7E66-4B7F-B4F1-B90959DDC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9944BD9-FBE1-176B-CFD3-702C1D205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97E8DC1-4D38-422C-A860-33149980C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981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42E87C8-D6A1-C9D5-E051-DC28484C3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0A36C04-42F7-474E-E683-F53A0B31E3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CB26E9AE-C1A6-24FF-6AE2-8B88FF3C5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04765C8-04B2-E168-C16B-2630C04CF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E890B96D-3B20-62D4-0BCB-1D2487F65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643B05C9-E7C8-2EB7-D1F1-22477FEA1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396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5BEAE7C-9966-A01A-4B24-F60166A731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C65B905-FCE8-9F8A-540F-4F965ECC6C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84F40E42-CA8E-6291-443B-4B3F7F32B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10FD6617-1BC7-D1C5-8DDF-A8D6DFD889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0B1FA7FB-5FD6-450F-8356-718B0BA62B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C28D10CF-BD49-57F4-7878-42241D917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560BB589-FA12-643F-0AF4-166AFEFB0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8B82587D-2B73-5DBF-B56E-ABBC49EE6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4135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A4BF08B-B244-0D9C-8D48-A030EB2F29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B5A1ACBB-8AAF-BCF5-AE87-072A4356F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FAB137D3-99EF-505A-2E99-FA46742F7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920F9DF6-814A-F635-9716-92C03DE0C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67096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4ABC4303-3455-10FF-C0C5-D31E13CE2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EA7AB82E-637B-D9A6-3883-27F9E570F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FFAC9155-5A35-1436-561A-CCABA3A78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4045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09A0A91-B216-C142-1ACF-C54A74501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3FD46C1-C954-BF0F-AD32-F9751845DF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ECB80AC-9C60-28AA-1B99-BADDC5FF30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A70C49F1-E4F8-DFEB-1C1D-C70D679D5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079C9474-E95B-32C4-CE79-DFBF20B9E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24F587B-5BE1-20C0-4B0B-4EC6C775C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68024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49B5597-8BAE-6635-7C97-B178AB864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40838F71-2A3C-1B67-200F-DE06D72CA6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958D75F5-D52B-4BAA-8598-2787A40ABB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468205D-B32E-1445-5587-E96D83CA4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82E1CA0-1616-9616-4A7E-D29AA8189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F01FCE8C-3F89-1C2D-4C52-A74673323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04382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2C86DE3E-DD5A-9865-EF70-522C749E4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974DD131-7966-C1DA-7CC0-B83374E678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FAB7910-DE7C-BB72-4207-2A9C2894A9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0AA34-2349-49F8-8B2F-315C2280449E}" type="datetimeFigureOut">
              <a:rPr lang="zh-TW" altLang="en-US" smtClean="0"/>
              <a:t>2023/11/24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B54FA2E-1597-1FCB-A9B0-0772A9A7EC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6AF669B-6EBF-0ADA-56F0-BE68B6D631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9FA22F-D161-4E15-B5DD-838A8BA674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00386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群組 14">
            <a:extLst>
              <a:ext uri="{FF2B5EF4-FFF2-40B4-BE49-F238E27FC236}">
                <a16:creationId xmlns:a16="http://schemas.microsoft.com/office/drawing/2014/main" id="{081E4C94-74E6-A347-389E-71B954A5878C}"/>
              </a:ext>
            </a:extLst>
          </p:cNvPr>
          <p:cNvGrpSpPr/>
          <p:nvPr/>
        </p:nvGrpSpPr>
        <p:grpSpPr>
          <a:xfrm>
            <a:off x="1762442" y="557211"/>
            <a:ext cx="5619115" cy="5230614"/>
            <a:chOff x="1762442" y="557211"/>
            <a:chExt cx="5619115" cy="5230614"/>
          </a:xfrm>
        </p:grpSpPr>
        <p:sp>
          <p:nvSpPr>
            <p:cNvPr id="2" name="文字方塊 2">
              <a:extLst>
                <a:ext uri="{FF2B5EF4-FFF2-40B4-BE49-F238E27FC236}">
                  <a16:creationId xmlns:a16="http://schemas.microsoft.com/office/drawing/2014/main" id="{AC7B9465-C7F4-9FFC-63F0-8AC29F8F70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2442" y="557211"/>
              <a:ext cx="4466590" cy="32893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22,563 potentially eligible subjects by age and residence registration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3" name="文字方塊 2">
              <a:extLst>
                <a:ext uri="{FF2B5EF4-FFF2-40B4-BE49-F238E27FC236}">
                  <a16:creationId xmlns:a16="http://schemas.microsoft.com/office/drawing/2014/main" id="{12580BDF-1311-3665-EAB0-4D79A34E81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00542" y="4452936"/>
              <a:ext cx="1562100" cy="32893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5,664 were recruited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4" name="向下箭號 2">
              <a:extLst>
                <a:ext uri="{FF2B5EF4-FFF2-40B4-BE49-F238E27FC236}">
                  <a16:creationId xmlns:a16="http://schemas.microsoft.com/office/drawing/2014/main" id="{9F80870A-608E-7EE6-0435-1C2D38ACEE39}"/>
                </a:ext>
              </a:extLst>
            </p:cNvPr>
            <p:cNvSpPr/>
            <p:nvPr/>
          </p:nvSpPr>
          <p:spPr>
            <a:xfrm>
              <a:off x="1943417" y="890586"/>
              <a:ext cx="266065" cy="2047875"/>
            </a:xfrm>
            <a:prstGeom prst="downArrow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5" name="向右箭號 3">
              <a:extLst>
                <a:ext uri="{FF2B5EF4-FFF2-40B4-BE49-F238E27FC236}">
                  <a16:creationId xmlns:a16="http://schemas.microsoft.com/office/drawing/2014/main" id="{130918D3-071B-6050-64FE-8399714FAB92}"/>
                </a:ext>
              </a:extLst>
            </p:cNvPr>
            <p:cNvSpPr/>
            <p:nvPr/>
          </p:nvSpPr>
          <p:spPr>
            <a:xfrm>
              <a:off x="2143442" y="1156651"/>
              <a:ext cx="714375" cy="266065"/>
            </a:xfrm>
            <a:prstGeom prst="rightArrow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6" name="文字方塊 2">
              <a:extLst>
                <a:ext uri="{FF2B5EF4-FFF2-40B4-BE49-F238E27FC236}">
                  <a16:creationId xmlns:a16="http://schemas.microsoft.com/office/drawing/2014/main" id="{CA4621A5-2802-1AAC-178E-47848D5231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57817" y="976311"/>
              <a:ext cx="4523740" cy="18859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342900" lvl="0" indent="-342900">
                <a:buFont typeface="+mj-lt"/>
                <a:buAutoNum type="arabi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Missed invitation to participate (n=6,968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Declined to be invited (n=8,610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Refused without a reason (n=4,978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Did not want participate in the physical examination (n=916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Had participated in physical examinations regularly (n=872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Did not have time (n=801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Went to another hospital regularly (n=392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742950" lvl="1" indent="-285750">
                <a:buFont typeface="+mj-lt"/>
                <a:buAutoNum type="alphaLcPeriod"/>
              </a:pPr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Others (n=651)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7" name="向下箭號 4">
              <a:extLst>
                <a:ext uri="{FF2B5EF4-FFF2-40B4-BE49-F238E27FC236}">
                  <a16:creationId xmlns:a16="http://schemas.microsoft.com/office/drawing/2014/main" id="{53EFFCD1-061B-A6C5-EEFB-D9C0B5A69AF0}"/>
                </a:ext>
              </a:extLst>
            </p:cNvPr>
            <p:cNvSpPr/>
            <p:nvPr/>
          </p:nvSpPr>
          <p:spPr>
            <a:xfrm>
              <a:off x="2438717" y="4795836"/>
              <a:ext cx="266700" cy="720000"/>
            </a:xfrm>
            <a:prstGeom prst="downArrow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8" name="文字方塊 2">
              <a:extLst>
                <a:ext uri="{FF2B5EF4-FFF2-40B4-BE49-F238E27FC236}">
                  <a16:creationId xmlns:a16="http://schemas.microsoft.com/office/drawing/2014/main" id="{AE5F9A9E-0E8F-D70A-3A76-84F82359FA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2442" y="2938461"/>
              <a:ext cx="2552700" cy="32893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US" sz="1100" kern="10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6,985 subjects assessed for eligibility</a:t>
              </a:r>
              <a:endParaRPr lang="zh-TW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9" name="向下箭號 8">
              <a:extLst>
                <a:ext uri="{FF2B5EF4-FFF2-40B4-BE49-F238E27FC236}">
                  <a16:creationId xmlns:a16="http://schemas.microsoft.com/office/drawing/2014/main" id="{4C84BAD4-F418-A968-205C-F2E842BF80B8}"/>
                </a:ext>
              </a:extLst>
            </p:cNvPr>
            <p:cNvSpPr/>
            <p:nvPr/>
          </p:nvSpPr>
          <p:spPr>
            <a:xfrm>
              <a:off x="1943417" y="3271836"/>
              <a:ext cx="266700" cy="1181100"/>
            </a:xfrm>
            <a:prstGeom prst="downArrow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10" name="向右箭號 9">
              <a:extLst>
                <a:ext uri="{FF2B5EF4-FFF2-40B4-BE49-F238E27FC236}">
                  <a16:creationId xmlns:a16="http://schemas.microsoft.com/office/drawing/2014/main" id="{81C2DBF0-05B4-53B8-206C-048ABDBC4997}"/>
                </a:ext>
              </a:extLst>
            </p:cNvPr>
            <p:cNvSpPr/>
            <p:nvPr/>
          </p:nvSpPr>
          <p:spPr>
            <a:xfrm>
              <a:off x="2143442" y="3528376"/>
              <a:ext cx="1304925" cy="266065"/>
            </a:xfrm>
            <a:prstGeom prst="rightArrow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11" name="文字方塊 2">
              <a:extLst>
                <a:ext uri="{FF2B5EF4-FFF2-40B4-BE49-F238E27FC236}">
                  <a16:creationId xmlns:a16="http://schemas.microsoft.com/office/drawing/2014/main" id="{C280DDD4-A970-5F47-1CAD-82353C758C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48367" y="3338511"/>
              <a:ext cx="2428875" cy="14573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Unable to move (n=294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Deaf or difficult to hear (n=268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Blind (n=118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Too ill to participate (n=117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Dementia (n=116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  <a:p>
              <a:pPr marL="342900" lvl="0" indent="-342900">
                <a:buFont typeface="+mj-lt"/>
                <a:buAutoNum type="arabicPeriod"/>
              </a:pPr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Other exclusion criteria (n=408)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2A91C37F-40B1-59C3-CC23-C010C546D7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00542" y="5526215"/>
              <a:ext cx="1562100" cy="26161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5,66</a:t>
              </a:r>
              <a:r>
                <a:rPr lang="en-US" altLang="zh-TW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3</a:t>
              </a:r>
              <a:r>
                <a:rPr lang="zh-TW" altLang="en-US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</a:t>
              </a:r>
              <a:r>
                <a:rPr lang="en-US" altLang="zh-TW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at baseline</a:t>
              </a:r>
              <a:endParaRPr lang="zh-TW" sz="1200" kern="100" dirty="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13" name="向右箭號 9">
              <a:extLst>
                <a:ext uri="{FF2B5EF4-FFF2-40B4-BE49-F238E27FC236}">
                  <a16:creationId xmlns:a16="http://schemas.microsoft.com/office/drawing/2014/main" id="{A9C39341-BA72-E630-6022-44703AAD0915}"/>
                </a:ext>
              </a:extLst>
            </p:cNvPr>
            <p:cNvSpPr/>
            <p:nvPr/>
          </p:nvSpPr>
          <p:spPr>
            <a:xfrm>
              <a:off x="2636502" y="4982208"/>
              <a:ext cx="1304925" cy="266065"/>
            </a:xfrm>
            <a:prstGeom prst="rightArrow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  <p:sp>
          <p:nvSpPr>
            <p:cNvPr id="14" name="文字方塊 2">
              <a:extLst>
                <a:ext uri="{FF2B5EF4-FFF2-40B4-BE49-F238E27FC236}">
                  <a16:creationId xmlns:a16="http://schemas.microsoft.com/office/drawing/2014/main" id="{34B66733-8622-373F-4361-511D54522A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41427" y="4972364"/>
              <a:ext cx="1114669" cy="28575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lvl="0"/>
              <a:r>
                <a:rPr lang="en-US" altLang="zh-TW" sz="1100" kern="100" dirty="0"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rPr>
                <a:t>1 withdraw</a:t>
              </a:r>
              <a:endParaRPr lang="zh-TW" sz="11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5399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群組 19">
            <a:extLst>
              <a:ext uri="{FF2B5EF4-FFF2-40B4-BE49-F238E27FC236}">
                <a16:creationId xmlns:a16="http://schemas.microsoft.com/office/drawing/2014/main" id="{53984DFB-5915-454B-82DA-D510DBE56AD7}"/>
              </a:ext>
            </a:extLst>
          </p:cNvPr>
          <p:cNvGrpSpPr/>
          <p:nvPr/>
        </p:nvGrpSpPr>
        <p:grpSpPr>
          <a:xfrm>
            <a:off x="1860658" y="1095743"/>
            <a:ext cx="5290506" cy="4943512"/>
            <a:chOff x="2837811" y="554182"/>
            <a:chExt cx="5290506" cy="4943512"/>
          </a:xfrm>
        </p:grpSpPr>
        <p:sp>
          <p:nvSpPr>
            <p:cNvPr id="4" name="文字方塊 3">
              <a:extLst>
                <a:ext uri="{FF2B5EF4-FFF2-40B4-BE49-F238E27FC236}">
                  <a16:creationId xmlns:a16="http://schemas.microsoft.com/office/drawing/2014/main" id="{7BBC826A-F3F3-8AC4-510A-923589C3CBA9}"/>
                </a:ext>
              </a:extLst>
            </p:cNvPr>
            <p:cNvSpPr txBox="1"/>
            <p:nvPr/>
          </p:nvSpPr>
          <p:spPr>
            <a:xfrm>
              <a:off x="3592941" y="554182"/>
              <a:ext cx="2037737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Baseline, n=5,663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箭號: 向下 4">
              <a:extLst>
                <a:ext uri="{FF2B5EF4-FFF2-40B4-BE49-F238E27FC236}">
                  <a16:creationId xmlns:a16="http://schemas.microsoft.com/office/drawing/2014/main" id="{5B264B1E-8546-4877-0C87-A682491621EF}"/>
                </a:ext>
              </a:extLst>
            </p:cNvPr>
            <p:cNvSpPr/>
            <p:nvPr/>
          </p:nvSpPr>
          <p:spPr>
            <a:xfrm>
              <a:off x="4451928" y="932873"/>
              <a:ext cx="258618" cy="692727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6" name="箭號: 向右 5">
              <a:extLst>
                <a:ext uri="{FF2B5EF4-FFF2-40B4-BE49-F238E27FC236}">
                  <a16:creationId xmlns:a16="http://schemas.microsoft.com/office/drawing/2014/main" id="{573CCEA0-A861-0562-6F69-0B5AB3F410C2}"/>
                </a:ext>
              </a:extLst>
            </p:cNvPr>
            <p:cNvSpPr/>
            <p:nvPr/>
          </p:nvSpPr>
          <p:spPr>
            <a:xfrm>
              <a:off x="4645891" y="1155250"/>
              <a:ext cx="554182" cy="259200"/>
            </a:xfrm>
            <a:prstGeom prst="right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ED627BCE-C900-7014-B1D0-5A40733A1058}"/>
                </a:ext>
              </a:extLst>
            </p:cNvPr>
            <p:cNvSpPr txBox="1"/>
            <p:nvPr/>
          </p:nvSpPr>
          <p:spPr>
            <a:xfrm>
              <a:off x="5218546" y="1094570"/>
              <a:ext cx="2909771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Covariates missing, n=233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27C73BC1-1F67-F0C6-A18F-648A6F1CD469}"/>
                </a:ext>
              </a:extLst>
            </p:cNvPr>
            <p:cNvSpPr txBox="1"/>
            <p:nvPr/>
          </p:nvSpPr>
          <p:spPr>
            <a:xfrm>
              <a:off x="2837811" y="1649335"/>
              <a:ext cx="3486852" cy="369332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aseline for estimation, n=5,430</a:t>
              </a:r>
              <a:endParaRPr lang="zh-TW" alt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箭號: 向下 8">
              <a:extLst>
                <a:ext uri="{FF2B5EF4-FFF2-40B4-BE49-F238E27FC236}">
                  <a16:creationId xmlns:a16="http://schemas.microsoft.com/office/drawing/2014/main" id="{BB8139E2-CF64-9BF5-9884-29BB6D231ED8}"/>
                </a:ext>
              </a:extLst>
            </p:cNvPr>
            <p:cNvSpPr/>
            <p:nvPr/>
          </p:nvSpPr>
          <p:spPr>
            <a:xfrm>
              <a:off x="4438075" y="2036615"/>
              <a:ext cx="258618" cy="974440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0" name="箭號: 向右 9">
              <a:extLst>
                <a:ext uri="{FF2B5EF4-FFF2-40B4-BE49-F238E27FC236}">
                  <a16:creationId xmlns:a16="http://schemas.microsoft.com/office/drawing/2014/main" id="{280FB381-F8E0-5B46-6BBC-F3CA1A879E9F}"/>
                </a:ext>
              </a:extLst>
            </p:cNvPr>
            <p:cNvSpPr/>
            <p:nvPr/>
          </p:nvSpPr>
          <p:spPr>
            <a:xfrm>
              <a:off x="4645891" y="2391877"/>
              <a:ext cx="554182" cy="259200"/>
            </a:xfrm>
            <a:prstGeom prst="right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C89EFB17-AFE3-2B80-7967-2F9B02B5AF7E}"/>
                </a:ext>
              </a:extLst>
            </p:cNvPr>
            <p:cNvSpPr txBox="1"/>
            <p:nvPr/>
          </p:nvSpPr>
          <p:spPr>
            <a:xfrm>
              <a:off x="5204693" y="2198312"/>
              <a:ext cx="2640466" cy="64633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ath, n=587</a:t>
              </a:r>
            </a:p>
            <a:p>
              <a:pPr algn="ctr"/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Lost to follow-up, n=777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33417881-66DE-ED39-4417-D1A8F32CC835}"/>
                </a:ext>
              </a:extLst>
            </p:cNvPr>
            <p:cNvSpPr txBox="1"/>
            <p:nvPr/>
          </p:nvSpPr>
          <p:spPr>
            <a:xfrm>
              <a:off x="3592940" y="3015239"/>
              <a:ext cx="1926553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Wave 2, n=4,066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群組 11">
              <a:extLst>
                <a:ext uri="{FF2B5EF4-FFF2-40B4-BE49-F238E27FC236}">
                  <a16:creationId xmlns:a16="http://schemas.microsoft.com/office/drawing/2014/main" id="{523024FF-70BE-1DF2-E73C-7A91B6E62E1E}"/>
                </a:ext>
              </a:extLst>
            </p:cNvPr>
            <p:cNvGrpSpPr/>
            <p:nvPr/>
          </p:nvGrpSpPr>
          <p:grpSpPr>
            <a:xfrm>
              <a:off x="4447311" y="3385129"/>
              <a:ext cx="748145" cy="692727"/>
              <a:chOff x="4447311" y="3385129"/>
              <a:chExt cx="748145" cy="692727"/>
            </a:xfrm>
          </p:grpSpPr>
          <p:sp>
            <p:nvSpPr>
              <p:cNvPr id="14" name="箭號: 向下 13">
                <a:extLst>
                  <a:ext uri="{FF2B5EF4-FFF2-40B4-BE49-F238E27FC236}">
                    <a16:creationId xmlns:a16="http://schemas.microsoft.com/office/drawing/2014/main" id="{161C7CC2-D9F8-3CE8-21F3-E5C63CCF9D15}"/>
                  </a:ext>
                </a:extLst>
              </p:cNvPr>
              <p:cNvSpPr/>
              <p:nvPr/>
            </p:nvSpPr>
            <p:spPr>
              <a:xfrm>
                <a:off x="4447311" y="3385129"/>
                <a:ext cx="258618" cy="692727"/>
              </a:xfrm>
              <a:prstGeom prst="downArrow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5" name="箭號: 向右 14">
                <a:extLst>
                  <a:ext uri="{FF2B5EF4-FFF2-40B4-BE49-F238E27FC236}">
                    <a16:creationId xmlns:a16="http://schemas.microsoft.com/office/drawing/2014/main" id="{D7E9A2C2-9897-69E2-40A8-C3B3648506B9}"/>
                  </a:ext>
                </a:extLst>
              </p:cNvPr>
              <p:cNvSpPr/>
              <p:nvPr/>
            </p:nvSpPr>
            <p:spPr>
              <a:xfrm>
                <a:off x="4641274" y="3607506"/>
                <a:ext cx="554182" cy="259200"/>
              </a:xfrm>
              <a:prstGeom prst="rightArrow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6288B2CB-2018-22D2-C0D0-BB2278C8928C}"/>
                </a:ext>
              </a:extLst>
            </p:cNvPr>
            <p:cNvSpPr txBox="1"/>
            <p:nvPr/>
          </p:nvSpPr>
          <p:spPr>
            <a:xfrm>
              <a:off x="5213929" y="3546826"/>
              <a:ext cx="2601994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Arial" panose="020B0604020202020204" pitchFamily="34" charset="0"/>
                  <a:cs typeface="Arial" panose="020B0604020202020204" pitchFamily="34" charset="0"/>
                </a:rPr>
                <a:t>Disability missing, n=21</a:t>
              </a:r>
              <a:endParaRPr lang="zh-TW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E824B839-0B63-EB03-14E0-0B51CCFC131E}"/>
                </a:ext>
              </a:extLst>
            </p:cNvPr>
            <p:cNvSpPr txBox="1"/>
            <p:nvPr/>
          </p:nvSpPr>
          <p:spPr>
            <a:xfrm>
              <a:off x="2879550" y="4093598"/>
              <a:ext cx="3375668" cy="369332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ave 2 for estimation, n=4,045</a:t>
              </a:r>
              <a:endParaRPr lang="zh-TW" alt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箭號: 上彎 2">
              <a:extLst>
                <a:ext uri="{FF2B5EF4-FFF2-40B4-BE49-F238E27FC236}">
                  <a16:creationId xmlns:a16="http://schemas.microsoft.com/office/drawing/2014/main" id="{12B6A566-53E7-8B14-E4C6-F7C8571587E4}"/>
                </a:ext>
              </a:extLst>
            </p:cNvPr>
            <p:cNvSpPr/>
            <p:nvPr/>
          </p:nvSpPr>
          <p:spPr>
            <a:xfrm rot="5400000">
              <a:off x="4475456" y="4500695"/>
              <a:ext cx="748800" cy="691200"/>
            </a:xfrm>
            <a:prstGeom prst="bentUp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id="{B142A392-BAC2-45AD-7943-8E5AE52CE0BF}"/>
                </a:ext>
              </a:extLst>
            </p:cNvPr>
            <p:cNvSpPr txBox="1"/>
            <p:nvPr/>
          </p:nvSpPr>
          <p:spPr>
            <a:xfrm>
              <a:off x="5124542" y="4851363"/>
              <a:ext cx="1736374" cy="646331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y 2021/10/31,</a:t>
              </a:r>
            </a:p>
            <a:p>
              <a:pPr algn="ctr"/>
              <a:r>
                <a:rPr lang="en-US" altLang="zh-TW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ath, n=718</a:t>
              </a:r>
              <a:endParaRPr lang="zh-TW" alt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3559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>
            <a:extLst>
              <a:ext uri="{FF2B5EF4-FFF2-40B4-BE49-F238E27FC236}">
                <a16:creationId xmlns:a16="http://schemas.microsoft.com/office/drawing/2014/main" id="{9F821C68-778B-83DC-3CF2-1570ADA04DC8}"/>
              </a:ext>
            </a:extLst>
          </p:cNvPr>
          <p:cNvGrpSpPr/>
          <p:nvPr/>
        </p:nvGrpSpPr>
        <p:grpSpPr>
          <a:xfrm>
            <a:off x="214312" y="2057400"/>
            <a:ext cx="8715375" cy="2743200"/>
            <a:chOff x="-7380" y="3604325"/>
            <a:chExt cx="8715375" cy="2743200"/>
          </a:xfrm>
        </p:grpSpPr>
        <p:graphicFrame>
          <p:nvGraphicFramePr>
            <p:cNvPr id="3" name="圖表 2">
              <a:extLst>
                <a:ext uri="{FF2B5EF4-FFF2-40B4-BE49-F238E27FC236}">
                  <a16:creationId xmlns:a16="http://schemas.microsoft.com/office/drawing/2014/main" id="{FF528F64-A7C2-103D-B1BD-4FE0AE4F8BA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1686342"/>
                </p:ext>
              </p:extLst>
            </p:nvPr>
          </p:nvGraphicFramePr>
          <p:xfrm>
            <a:off x="-7380" y="36043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圖表 3">
              <a:extLst>
                <a:ext uri="{FF2B5EF4-FFF2-40B4-BE49-F238E27FC236}">
                  <a16:creationId xmlns:a16="http://schemas.microsoft.com/office/drawing/2014/main" id="{E8F4DA46-023C-3185-C71D-DA119854ED8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7784815"/>
                </p:ext>
              </p:extLst>
            </p:nvPr>
          </p:nvGraphicFramePr>
          <p:xfrm>
            <a:off x="4564620" y="3604325"/>
            <a:ext cx="414337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995784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272</Words>
  <Application>Microsoft Office PowerPoint</Application>
  <PresentationFormat>如螢幕大小 (4:3)</PresentationFormat>
  <Paragraphs>57</Paragraphs>
  <Slides>3</Slides>
  <Notes>3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uangShu-Chun</dc:creator>
  <cp:lastModifiedBy>ChuangShu-Chun</cp:lastModifiedBy>
  <cp:revision>12</cp:revision>
  <dcterms:created xsi:type="dcterms:W3CDTF">2023-09-28T08:43:43Z</dcterms:created>
  <dcterms:modified xsi:type="dcterms:W3CDTF">2023-11-24T03:17:31Z</dcterms:modified>
</cp:coreProperties>
</file>